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F528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8" d="100"/>
          <a:sy n="48" d="100"/>
        </p:scale>
        <p:origin x="235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EEF573-D0A8-43D7-8844-001F68425B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2378CEE-76C2-4B64-B282-C00B363FB5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32866C-95F6-4711-81F8-4C9C3F94A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6439CF-320E-4AF2-934B-B0DF808372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FCF4CA-ACC3-43E0-BEBA-7AE7169AE9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0139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1FBAD4-5072-4BC8-8989-11DB162A8B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E889653-E472-4D30-9EF1-8D3CABC674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9FC5689-1D76-41AA-847B-854E2B099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A2B311-3455-4D36-82BA-DE3D6C8D7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A249F6-3D09-47C0-9542-624EC2FF1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273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8CA0884-45A3-4C0F-9F44-827FA0B4AB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62AD7FD-7473-4392-AFCF-5AEDE67DB5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814CE3-1415-494E-9428-0269F4DE2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2E62EC-18DA-4DFC-954E-33B96CA75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49234F-57FD-45EA-B074-7B43D4B92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2109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9A0DF2-B9D7-42D4-A294-80A96F0C07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A79DB0B-6D1F-40ED-BA71-88D4137F03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714978-2060-4BBD-94C0-CD0A1C57F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48209E-124B-4382-961B-FABB94FF50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6A950B6-65B0-4598-8BCE-9A9B56E8C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0304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F5A25F-ACE6-40CB-88C8-CE890ACEE8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3E3FD00-7A66-4068-A1BC-D57071ABBD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F652AC8-DCFA-4191-B0FF-1ED178294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40F2100-4E13-4EFC-AD4F-9D17AD58D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2C0324-3532-40EE-8B39-31CF68D25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882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912AC9-B00D-47A3-856C-93677A5BC7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1A97255-C930-489E-BFE3-D7B92F72E5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EBA2CAF-F1AA-46A3-8A9C-D284FD465C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E26E4B6-01AE-404A-80F4-F22156CA9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CCE708F-0BC5-47E5-B8E1-C4381CE8B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B666173-C874-4859-90F6-09FC146DDF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475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B8FD68-D562-4287-8FAE-91B96F8693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B1DB07E-547E-49B1-9737-9409FA35AC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C1E27B1-8438-4B42-83E0-38B49C86CD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D42076C-EA3C-4D22-8AE8-C85DAAC8D2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0696A65-F816-4F3F-BFBE-6F461BC8BC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968EB52-4B42-4B5A-9526-3FE5CD543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70F90F0-F915-4AEE-92D5-7A91AA206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DB8EE9E-5905-43BE-9E51-4AE6D5689C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9759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83901A-B29C-4A26-A10D-B2EBE2CE5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5998467-E371-4C92-A24C-64526ABB1D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704578C-CA1C-46F4-8474-0CCE14F06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D2CE281-AA7E-4FCF-ACC8-CDD1C19B1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4810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C7A8DE6-CED7-4ED1-B25C-A52C5ED28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12F68EA-47F8-439A-9171-D44386D0D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7B6451C-81FC-4511-9828-E5B8F81B9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7545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E6EA97-2DD9-4FA9-94E0-EFEA95309E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94E8FC3-00C1-40E9-AD0F-190B0DD80E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CF61072-D5E8-4D2C-8A36-51AF40DA25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0FF9D71-21A8-4213-9A92-C5AC7E8A7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5057598-19F6-4346-BCC9-CC78CB63C2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E1A7B7-F582-4DAD-B1EE-23FC63FA82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4700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FD91D6-D0BE-45B0-8ECC-CB482932B2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8E7ACE2-7091-4E6B-84B9-A00FDC179C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CFE60E-E57C-4B6F-AEB0-0A43E44978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99C9DA4-8D5B-44F0-9610-E1AAB0237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1927B48-E055-4375-8DB7-BA382A02A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71D3292-C5AC-4CFC-B68D-1E269FE19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3372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5F0EF24-A0D5-4E5C-A688-026DEDF57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D2DBD4E-6F03-4CDE-A6A9-72E2E8E6E4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BD2FC8-E192-4B33-BCF7-5EE7212215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0BA66B-0A1C-4356-8950-B648822003B1}" type="datetimeFigureOut">
              <a:rPr lang="zh-CN" altLang="en-US" smtClean="0"/>
              <a:t>2019/9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062028-AA49-47A6-9DEC-66AD543FC7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737D29-0E57-4373-868A-8F6EB169B6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D162E-9F17-434A-BFF0-3D700767E692}" type="slidenum">
              <a:rPr lang="zh-CN" altLang="en-US" smtClean="0"/>
              <a:t>‹N°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8473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26735CFA-8718-4FBB-9709-03F9C9007BF9}"/>
              </a:ext>
            </a:extLst>
          </p:cNvPr>
          <p:cNvCxnSpPr>
            <a:cxnSpLocks/>
          </p:cNvCxnSpPr>
          <p:nvPr/>
        </p:nvCxnSpPr>
        <p:spPr>
          <a:xfrm>
            <a:off x="2532971" y="2500292"/>
            <a:ext cx="3365003" cy="0"/>
          </a:xfrm>
          <a:prstGeom prst="line">
            <a:avLst/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矩形 9">
            <a:extLst>
              <a:ext uri="{FF2B5EF4-FFF2-40B4-BE49-F238E27FC236}">
                <a16:creationId xmlns:a16="http://schemas.microsoft.com/office/drawing/2014/main" id="{A3124DE8-C86F-46E6-9FB1-8EFB40E355B5}"/>
              </a:ext>
            </a:extLst>
          </p:cNvPr>
          <p:cNvSpPr/>
          <p:nvPr/>
        </p:nvSpPr>
        <p:spPr>
          <a:xfrm>
            <a:off x="4498808" y="2351886"/>
            <a:ext cx="1270784" cy="350729"/>
          </a:xfrm>
          <a:prstGeom prst="rect">
            <a:avLst/>
          </a:prstGeom>
          <a:solidFill>
            <a:schemeClr val="bg1"/>
          </a:solidFill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1C54FFBA-A141-4D84-9305-15689842C3E1}"/>
              </a:ext>
            </a:extLst>
          </p:cNvPr>
          <p:cNvSpPr/>
          <p:nvPr/>
        </p:nvSpPr>
        <p:spPr>
          <a:xfrm>
            <a:off x="2537878" y="2351887"/>
            <a:ext cx="1853852" cy="350729"/>
          </a:xfrm>
          <a:prstGeom prst="rect">
            <a:avLst/>
          </a:prstGeom>
          <a:solidFill>
            <a:schemeClr val="bg1"/>
          </a:solidFill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183C1DA-BB10-4E6F-9807-C4956E5EACB7}"/>
              </a:ext>
            </a:extLst>
          </p:cNvPr>
          <p:cNvSpPr txBox="1"/>
          <p:nvPr/>
        </p:nvSpPr>
        <p:spPr>
          <a:xfrm>
            <a:off x="1709622" y="234258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6336828-0A70-407A-BE61-3D7A9DF2DEBF}"/>
              </a:ext>
            </a:extLst>
          </p:cNvPr>
          <p:cNvSpPr txBox="1"/>
          <p:nvPr/>
        </p:nvSpPr>
        <p:spPr>
          <a:xfrm>
            <a:off x="2709629" y="2380981"/>
            <a:ext cx="15103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OX1 promote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60FF417-6FA9-4592-A81D-169E01406690}"/>
              </a:ext>
            </a:extLst>
          </p:cNvPr>
          <p:cNvSpPr txBox="1"/>
          <p:nvPr/>
        </p:nvSpPr>
        <p:spPr>
          <a:xfrm>
            <a:off x="4834799" y="2374746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D6470C14-E2F1-49B5-8B96-8F57B30BDFCF}"/>
              </a:ext>
            </a:extLst>
          </p:cNvPr>
          <p:cNvCxnSpPr>
            <a:cxnSpLocks/>
          </p:cNvCxnSpPr>
          <p:nvPr/>
        </p:nvCxnSpPr>
        <p:spPr>
          <a:xfrm>
            <a:off x="2532971" y="3238937"/>
            <a:ext cx="4061955" cy="0"/>
          </a:xfrm>
          <a:prstGeom prst="line">
            <a:avLst/>
          </a:prstGeom>
          <a:ln w="2857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矩形 18">
            <a:extLst>
              <a:ext uri="{FF2B5EF4-FFF2-40B4-BE49-F238E27FC236}">
                <a16:creationId xmlns:a16="http://schemas.microsoft.com/office/drawing/2014/main" id="{34E12D20-6045-4371-A603-9C118249E036}"/>
              </a:ext>
            </a:extLst>
          </p:cNvPr>
          <p:cNvSpPr/>
          <p:nvPr/>
        </p:nvSpPr>
        <p:spPr>
          <a:xfrm>
            <a:off x="4437848" y="3080780"/>
            <a:ext cx="782270" cy="350729"/>
          </a:xfrm>
          <a:prstGeom prst="rect">
            <a:avLst/>
          </a:prstGeom>
          <a:solidFill>
            <a:schemeClr val="bg1"/>
          </a:solidFill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A8B7680E-B21A-4DB7-A79B-D607842F427F}"/>
              </a:ext>
            </a:extLst>
          </p:cNvPr>
          <p:cNvSpPr/>
          <p:nvPr/>
        </p:nvSpPr>
        <p:spPr>
          <a:xfrm>
            <a:off x="2537878" y="3081006"/>
            <a:ext cx="1853852" cy="350729"/>
          </a:xfrm>
          <a:prstGeom prst="rect">
            <a:avLst/>
          </a:prstGeom>
          <a:solidFill>
            <a:schemeClr val="bg1"/>
          </a:solidFill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0BFCB57E-A034-47C9-8A64-B0A3FB7F6EE7}"/>
              </a:ext>
            </a:extLst>
          </p:cNvPr>
          <p:cNvSpPr txBox="1"/>
          <p:nvPr/>
        </p:nvSpPr>
        <p:spPr>
          <a:xfrm>
            <a:off x="-701666" y="3071703"/>
            <a:ext cx="30704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TR7[1-130] GST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F2BC907-A4F0-4F57-A698-704E895D7DFA}"/>
              </a:ext>
            </a:extLst>
          </p:cNvPr>
          <p:cNvSpPr txBox="1"/>
          <p:nvPr/>
        </p:nvSpPr>
        <p:spPr>
          <a:xfrm>
            <a:off x="2709629" y="3110100"/>
            <a:ext cx="15103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OX1 promote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2CD9D68B-FBC8-4359-BB39-6DB5A4B9E1C4}"/>
              </a:ext>
            </a:extLst>
          </p:cNvPr>
          <p:cNvSpPr txBox="1"/>
          <p:nvPr/>
        </p:nvSpPr>
        <p:spPr>
          <a:xfrm>
            <a:off x="4446061" y="3049909"/>
            <a:ext cx="782270" cy="4154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ETR7</a:t>
            </a:r>
          </a:p>
          <a:p>
            <a:pPr algn="ctr"/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[1-390]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314BEF3C-F28F-4254-99CF-C8BD7B0FFFD4}"/>
              </a:ext>
            </a:extLst>
          </p:cNvPr>
          <p:cNvSpPr/>
          <p:nvPr/>
        </p:nvSpPr>
        <p:spPr>
          <a:xfrm>
            <a:off x="5266236" y="3071703"/>
            <a:ext cx="1263478" cy="350729"/>
          </a:xfrm>
          <a:prstGeom prst="rect">
            <a:avLst/>
          </a:prstGeom>
          <a:solidFill>
            <a:schemeClr val="bg1"/>
          </a:solidFill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F2863EF-A103-4CD7-BFEA-5706A3197E7E}"/>
              </a:ext>
            </a:extLst>
          </p:cNvPr>
          <p:cNvSpPr txBox="1"/>
          <p:nvPr/>
        </p:nvSpPr>
        <p:spPr>
          <a:xfrm>
            <a:off x="5621296" y="3093178"/>
            <a:ext cx="5533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8ED063A4-C38A-467D-B65E-6CA3E4D5C94B}"/>
              </a:ext>
            </a:extLst>
          </p:cNvPr>
          <p:cNvCxnSpPr>
            <a:cxnSpLocks/>
          </p:cNvCxnSpPr>
          <p:nvPr/>
        </p:nvCxnSpPr>
        <p:spPr>
          <a:xfrm>
            <a:off x="2535352" y="2173521"/>
            <a:ext cx="0" cy="247650"/>
          </a:xfrm>
          <a:prstGeom prst="line">
            <a:avLst/>
          </a:prstGeom>
          <a:ln w="1905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528A9670-26E6-4D92-8B90-2D95F42BE7FF}"/>
              </a:ext>
            </a:extLst>
          </p:cNvPr>
          <p:cNvCxnSpPr>
            <a:cxnSpLocks/>
          </p:cNvCxnSpPr>
          <p:nvPr/>
        </p:nvCxnSpPr>
        <p:spPr>
          <a:xfrm>
            <a:off x="2532971" y="2180664"/>
            <a:ext cx="377719" cy="0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D89ED50C-212D-4E4D-86F6-E32C2ED4D9F8}"/>
              </a:ext>
            </a:extLst>
          </p:cNvPr>
          <p:cNvCxnSpPr>
            <a:cxnSpLocks/>
          </p:cNvCxnSpPr>
          <p:nvPr/>
        </p:nvCxnSpPr>
        <p:spPr>
          <a:xfrm>
            <a:off x="2538527" y="2897421"/>
            <a:ext cx="0" cy="247650"/>
          </a:xfrm>
          <a:prstGeom prst="line">
            <a:avLst/>
          </a:prstGeom>
          <a:ln w="19050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3F474CE9-0ADB-4BC6-B866-5938ADA76C0F}"/>
              </a:ext>
            </a:extLst>
          </p:cNvPr>
          <p:cNvCxnSpPr>
            <a:cxnSpLocks/>
          </p:cNvCxnSpPr>
          <p:nvPr/>
        </p:nvCxnSpPr>
        <p:spPr>
          <a:xfrm>
            <a:off x="2536146" y="2895038"/>
            <a:ext cx="377719" cy="0"/>
          </a:xfrm>
          <a:prstGeom prst="straightConnector1">
            <a:avLst/>
          </a:prstGeom>
          <a:ln w="19050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C0FD0F0C-6143-4E95-8333-C1845ED0F5E9}"/>
              </a:ext>
            </a:extLst>
          </p:cNvPr>
          <p:cNvSpPr txBox="1"/>
          <p:nvPr/>
        </p:nvSpPr>
        <p:spPr>
          <a:xfrm>
            <a:off x="2417187" y="265970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982A99A-294B-48F5-9323-CA16E41D3311}"/>
              </a:ext>
            </a:extLst>
          </p:cNvPr>
          <p:cNvSpPr txBox="1"/>
          <p:nvPr/>
        </p:nvSpPr>
        <p:spPr>
          <a:xfrm>
            <a:off x="4360933" y="266390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981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C1C5056-5AFA-4E99-8F30-58F8C1A65630}"/>
              </a:ext>
            </a:extLst>
          </p:cNvPr>
          <p:cNvSpPr txBox="1"/>
          <p:nvPr/>
        </p:nvSpPr>
        <p:spPr>
          <a:xfrm>
            <a:off x="5555247" y="2652859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637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F846FB7-EC6F-450D-968C-720D3BA8BDE3}"/>
              </a:ext>
            </a:extLst>
          </p:cNvPr>
          <p:cNvSpPr txBox="1"/>
          <p:nvPr/>
        </p:nvSpPr>
        <p:spPr>
          <a:xfrm>
            <a:off x="4119249" y="266649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939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B4415D6-DA54-45B7-B667-B54D4DA280F7}"/>
              </a:ext>
            </a:extLst>
          </p:cNvPr>
          <p:cNvSpPr txBox="1"/>
          <p:nvPr/>
        </p:nvSpPr>
        <p:spPr>
          <a:xfrm>
            <a:off x="4308329" y="2160780"/>
            <a:ext cx="553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pnI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A08B4298-7868-4FE3-A102-2481FBB81F26}"/>
              </a:ext>
            </a:extLst>
          </p:cNvPr>
          <p:cNvSpPr txBox="1"/>
          <p:nvPr/>
        </p:nvSpPr>
        <p:spPr>
          <a:xfrm>
            <a:off x="5540958" y="2151500"/>
            <a:ext cx="553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otI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6AECC32E-782E-4649-B5D6-295383B3EBD2}"/>
              </a:ext>
            </a:extLst>
          </p:cNvPr>
          <p:cNvSpPr txBox="1"/>
          <p:nvPr/>
        </p:nvSpPr>
        <p:spPr>
          <a:xfrm>
            <a:off x="2417187" y="33955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F14597DF-752B-4E7C-86CB-FA4975F0B892}"/>
              </a:ext>
            </a:extLst>
          </p:cNvPr>
          <p:cNvSpPr txBox="1"/>
          <p:nvPr/>
        </p:nvSpPr>
        <p:spPr>
          <a:xfrm>
            <a:off x="4363790" y="339495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942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D9BC071A-FAA1-47EC-901E-A673D181D372}"/>
              </a:ext>
            </a:extLst>
          </p:cNvPr>
          <p:cNvSpPr txBox="1"/>
          <p:nvPr/>
        </p:nvSpPr>
        <p:spPr>
          <a:xfrm>
            <a:off x="4924657" y="3393437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342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B8E5A657-5351-490D-812F-CA2B19D94298}"/>
              </a:ext>
            </a:extLst>
          </p:cNvPr>
          <p:cNvSpPr txBox="1"/>
          <p:nvPr/>
        </p:nvSpPr>
        <p:spPr>
          <a:xfrm>
            <a:off x="4112330" y="339285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939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7AD1A6A-E0C8-4D29-88E6-7347E0B6E6D7}"/>
              </a:ext>
            </a:extLst>
          </p:cNvPr>
          <p:cNvSpPr txBox="1"/>
          <p:nvPr/>
        </p:nvSpPr>
        <p:spPr>
          <a:xfrm>
            <a:off x="5218134" y="3388264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1343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4FB26E2B-D797-47C5-980E-59F051E725E1}"/>
              </a:ext>
            </a:extLst>
          </p:cNvPr>
          <p:cNvSpPr txBox="1"/>
          <p:nvPr/>
        </p:nvSpPr>
        <p:spPr>
          <a:xfrm>
            <a:off x="6272765" y="3383501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85EA0578-94ED-4635-8D82-397971740E49}"/>
              </a:ext>
            </a:extLst>
          </p:cNvPr>
          <p:cNvSpPr txBox="1"/>
          <p:nvPr/>
        </p:nvSpPr>
        <p:spPr>
          <a:xfrm>
            <a:off x="4270047" y="2897315"/>
            <a:ext cx="553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EcoRI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59612039-4A1E-47BB-AF4E-CA9F0CE06836}"/>
              </a:ext>
            </a:extLst>
          </p:cNvPr>
          <p:cNvSpPr txBox="1"/>
          <p:nvPr/>
        </p:nvSpPr>
        <p:spPr>
          <a:xfrm>
            <a:off x="6304645" y="2887631"/>
            <a:ext cx="553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NotI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976DD8AC-2893-4AB0-ACBA-7ED9849C21EE}"/>
              </a:ext>
            </a:extLst>
          </p:cNvPr>
          <p:cNvSpPr txBox="1"/>
          <p:nvPr/>
        </p:nvSpPr>
        <p:spPr>
          <a:xfrm>
            <a:off x="5041298" y="2897314"/>
            <a:ext cx="553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pnI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4CDDE877-B831-4D70-94E8-0EEB2DFD3C04}"/>
              </a:ext>
            </a:extLst>
          </p:cNvPr>
          <p:cNvSpPr/>
          <p:nvPr/>
        </p:nvSpPr>
        <p:spPr>
          <a:xfrm>
            <a:off x="479925" y="4424095"/>
            <a:ext cx="579283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54000" indent="127000">
              <a:spcAft>
                <a:spcPts val="0"/>
              </a:spcAft>
            </a:pPr>
            <a:r>
              <a:rPr lang="en-US" altLang="zh-CN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upp. Fig. </a:t>
            </a:r>
            <a:r>
              <a:rPr lang="en-US" altLang="zh-CN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3.</a:t>
            </a:r>
            <a:r>
              <a:rPr lang="en-US" altLang="zh-CN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ea typeface="Calibri" panose="020F0502020204030204" pitchFamily="34" charset="0"/>
              </a:rPr>
              <a:t>Schematic representation of </a:t>
            </a:r>
            <a:r>
              <a:rPr lang="en-US" altLang="zh-CN" dirty="0" err="1">
                <a:latin typeface="Times New Roman" panose="02020603050405020304" pitchFamily="18" charset="0"/>
                <a:ea typeface="Calibri" panose="020F0502020204030204" pitchFamily="34" charset="0"/>
              </a:rPr>
              <a:t>pPICZ</a:t>
            </a:r>
            <a:r>
              <a:rPr lang="en-US" altLang="zh-CN" dirty="0">
                <a:latin typeface="Times New Roman" panose="02020603050405020304" pitchFamily="18" charset="0"/>
                <a:ea typeface="Calibri" panose="020F0502020204030204" pitchFamily="34" charset="0"/>
              </a:rPr>
              <a:t> A-GST and </a:t>
            </a:r>
            <a:r>
              <a:rPr lang="en-US" altLang="zh-CN" dirty="0" err="1">
                <a:latin typeface="Times New Roman" panose="02020603050405020304" pitchFamily="18" charset="0"/>
                <a:ea typeface="Calibri" panose="020F0502020204030204" pitchFamily="34" charset="0"/>
              </a:rPr>
              <a:t>pPICZ</a:t>
            </a:r>
            <a:r>
              <a:rPr lang="en-US" altLang="zh-CN" dirty="0">
                <a:latin typeface="Times New Roman" panose="02020603050405020304" pitchFamily="18" charset="0"/>
                <a:ea typeface="Calibri" panose="020F0502020204030204" pitchFamily="34" charset="0"/>
              </a:rPr>
              <a:t> A ETR7[1-390]GST constructs used for ethylene binding assays. </a:t>
            </a:r>
            <a:r>
              <a:rPr lang="en-US" altLang="zh-CN" sz="1400" dirty="0">
                <a:latin typeface="Helvetica Neue"/>
                <a:ea typeface="宋体" panose="02010600030101010101" pitchFamily="2" charset="-122"/>
                <a:cs typeface="Helvetica Neue"/>
              </a:rPr>
              <a:t> </a:t>
            </a:r>
            <a:r>
              <a:rPr lang="zh-CN" altLang="zh-CN" dirty="0"/>
              <a:t> </a:t>
            </a:r>
            <a:r>
              <a:rPr lang="en-US" altLang="zh-CN" sz="1400" dirty="0">
                <a:latin typeface="Helvetica Neue"/>
                <a:ea typeface="宋体" panose="02010600030101010101" pitchFamily="2" charset="-122"/>
                <a:cs typeface="Helvetica Neue"/>
              </a:rPr>
              <a:t> </a:t>
            </a:r>
            <a:endParaRPr lang="zh-CN" altLang="zh-CN" dirty="0">
              <a:latin typeface="Helvetica Neue"/>
              <a:ea typeface="宋体" panose="02010600030101010101" pitchFamily="2" charset="-122"/>
              <a:cs typeface="Helvetica Neue"/>
            </a:endParaRPr>
          </a:p>
        </p:txBody>
      </p:sp>
    </p:spTree>
    <p:extLst>
      <p:ext uri="{BB962C8B-B14F-4D97-AF65-F5344CB8AC3E}">
        <p14:creationId xmlns:p14="http://schemas.microsoft.com/office/powerpoint/2010/main" val="3956473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3</TotalTime>
  <Words>51</Words>
  <Application>Microsoft Office PowerPoint</Application>
  <PresentationFormat>Format A4 (210 x 297 mm)</PresentationFormat>
  <Paragraphs>2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7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9" baseType="lpstr">
      <vt:lpstr>宋体</vt:lpstr>
      <vt:lpstr>Arial</vt:lpstr>
      <vt:lpstr>Calibri</vt:lpstr>
      <vt:lpstr>等线</vt:lpstr>
      <vt:lpstr>等线 Light</vt:lpstr>
      <vt:lpstr>Helvetica Neue</vt:lpstr>
      <vt:lpstr>Times New Roman</vt:lpstr>
      <vt:lpstr>Office 主题​​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yi</dc:creator>
  <cp:lastModifiedBy>cchervin</cp:lastModifiedBy>
  <cp:revision>13</cp:revision>
  <dcterms:created xsi:type="dcterms:W3CDTF">2019-08-08T13:54:38Z</dcterms:created>
  <dcterms:modified xsi:type="dcterms:W3CDTF">2019-09-29T19:11:19Z</dcterms:modified>
</cp:coreProperties>
</file>